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1.xml" ContentType="application/vnd.ms-office.chartcolorstyle+xml"/>
  <Override PartName="/ppt/charts/style1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6" r:id="rId2"/>
  </p:sldIdLst>
  <p:sldSz cx="7559675" cy="10691813"/>
  <p:notesSz cx="6858000" cy="9947275"/>
  <p:defaultTextStyle>
    <a:defPPr>
      <a:defRPr lang="es-ES"/>
    </a:defPPr>
    <a:lvl1pPr marL="0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1pPr>
    <a:lvl2pPr marL="521437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2pPr>
    <a:lvl3pPr marL="1042873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3pPr>
    <a:lvl4pPr marL="1564310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4pPr>
    <a:lvl5pPr marL="2085746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5pPr>
    <a:lvl6pPr marL="2607183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6pPr>
    <a:lvl7pPr marL="3128620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7pPr>
    <a:lvl8pPr marL="3650056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8pPr>
    <a:lvl9pPr marL="4171493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368" userDrawn="1">
          <p15:clr>
            <a:srgbClr val="A4A3A4"/>
          </p15:clr>
        </p15:guide>
        <p15:guide id="2" pos="2381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ª Carmen Bolarín" initials="MCB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8181"/>
    <a:srgbClr val="FFB7B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968" autoAdjust="0"/>
  </p:normalViewPr>
  <p:slideViewPr>
    <p:cSldViewPr>
      <p:cViewPr>
        <p:scale>
          <a:sx n="70" d="100"/>
          <a:sy n="70" d="100"/>
        </p:scale>
        <p:origin x="-1638" y="-18"/>
      </p:cViewPr>
      <p:guideLst>
        <p:guide orient="horz" pos="3368"/>
        <p:guide pos="23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Salt%20VII\Dropbox\Caracterizaci&#243;n_funcional_RNA_helicase_339\Microarray_339_Mayo'15\Listas_genes_FC1,5_FC2_pv0.05_conosinFDR\VALIDACION%20MICROARRAY\Validaci&#243;n\RESULTADOS_VALIDACION.xlsx" TargetMode="External"/><Relationship Id="rId4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3.3159667541557303E-2"/>
          <c:y val="2.5428331875182269E-2"/>
          <c:w val="0.93750699912510937"/>
          <c:h val="0.94914333624963543"/>
        </c:manualLayout>
      </c:layout>
      <c:scatterChart>
        <c:scatterStyle val="lineMarker"/>
        <c:varyColors val="0"/>
        <c:ser>
          <c:idx val="0"/>
          <c:order val="0"/>
          <c:tx>
            <c:v>Microarray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('Selección final'!$F$4:$F$15,'Selección final'!$F$17:$F$30,'Selección final'!$F$32:$F$34,'Selección final'!$F$38:$F$41,'Selección final'!$F$42:$F$47)</c:f>
              <c:numCache>
                <c:formatCode>0.0</c:formatCode>
                <c:ptCount val="39"/>
                <c:pt idx="0">
                  <c:v>26</c:v>
                </c:pt>
                <c:pt idx="1">
                  <c:v>8.5</c:v>
                </c:pt>
                <c:pt idx="2">
                  <c:v>14.1</c:v>
                </c:pt>
                <c:pt idx="3">
                  <c:v>5.2</c:v>
                </c:pt>
                <c:pt idx="4">
                  <c:v>14.87</c:v>
                </c:pt>
                <c:pt idx="5">
                  <c:v>4.58</c:v>
                </c:pt>
                <c:pt idx="6">
                  <c:v>-3.5</c:v>
                </c:pt>
                <c:pt idx="7">
                  <c:v>19.14</c:v>
                </c:pt>
                <c:pt idx="8">
                  <c:v>-16.3</c:v>
                </c:pt>
                <c:pt idx="9">
                  <c:v>13.12</c:v>
                </c:pt>
                <c:pt idx="10">
                  <c:v>-21.9</c:v>
                </c:pt>
                <c:pt idx="11">
                  <c:v>-15.23</c:v>
                </c:pt>
                <c:pt idx="12">
                  <c:v>13.278</c:v>
                </c:pt>
                <c:pt idx="13">
                  <c:v>2.2559999999999998</c:v>
                </c:pt>
                <c:pt idx="14">
                  <c:v>-4.4000000000000004</c:v>
                </c:pt>
                <c:pt idx="15">
                  <c:v>-5.0599999999999996</c:v>
                </c:pt>
                <c:pt idx="16">
                  <c:v>6.82</c:v>
                </c:pt>
                <c:pt idx="17">
                  <c:v>2.2999999999999998</c:v>
                </c:pt>
                <c:pt idx="18">
                  <c:v>-14.4</c:v>
                </c:pt>
                <c:pt idx="19">
                  <c:v>9.57</c:v>
                </c:pt>
                <c:pt idx="20">
                  <c:v>12.526</c:v>
                </c:pt>
                <c:pt idx="21">
                  <c:v>30.33</c:v>
                </c:pt>
                <c:pt idx="22">
                  <c:v>7.61</c:v>
                </c:pt>
                <c:pt idx="23">
                  <c:v>-5</c:v>
                </c:pt>
                <c:pt idx="24">
                  <c:v>36.44</c:v>
                </c:pt>
                <c:pt idx="25">
                  <c:v>31.27</c:v>
                </c:pt>
                <c:pt idx="26">
                  <c:v>2.87</c:v>
                </c:pt>
                <c:pt idx="27">
                  <c:v>-5.01</c:v>
                </c:pt>
                <c:pt idx="28">
                  <c:v>22.38</c:v>
                </c:pt>
                <c:pt idx="29">
                  <c:v>-15.8</c:v>
                </c:pt>
                <c:pt idx="30">
                  <c:v>2.7</c:v>
                </c:pt>
                <c:pt idx="31">
                  <c:v>32.318199999999997</c:v>
                </c:pt>
                <c:pt idx="32">
                  <c:v>-11.6486</c:v>
                </c:pt>
                <c:pt idx="33">
                  <c:v>-24.946300000000001</c:v>
                </c:pt>
                <c:pt idx="34">
                  <c:v>19.399999999999999</c:v>
                </c:pt>
                <c:pt idx="35">
                  <c:v>-38.040399999999998</c:v>
                </c:pt>
                <c:pt idx="36">
                  <c:v>11.2</c:v>
                </c:pt>
                <c:pt idx="37">
                  <c:v>30.85</c:v>
                </c:pt>
                <c:pt idx="38">
                  <c:v>17.07</c:v>
                </c:pt>
              </c:numCache>
            </c:numRef>
          </c:xVal>
          <c:yVal>
            <c:numRef>
              <c:f>('Selección final'!$G$4:$G$15,'Selección final'!$G$17:$G$30,'Selección final'!$G$32:$G$34,'Selección final'!$G$38:$G$41,'Selección final'!$G$42:$G$47)</c:f>
              <c:numCache>
                <c:formatCode>0.0</c:formatCode>
                <c:ptCount val="39"/>
                <c:pt idx="0">
                  <c:v>5.1512830222647219</c:v>
                </c:pt>
                <c:pt idx="1">
                  <c:v>3.5233932941764929</c:v>
                </c:pt>
                <c:pt idx="2">
                  <c:v>4.5957196598867576</c:v>
                </c:pt>
                <c:pt idx="3">
                  <c:v>2.5117252732026878</c:v>
                </c:pt>
                <c:pt idx="4">
                  <c:v>4.5461886082186309</c:v>
                </c:pt>
                <c:pt idx="5">
                  <c:v>2.2084566134733623</c:v>
                </c:pt>
                <c:pt idx="6">
                  <c:v>-2.4886701164927127</c:v>
                </c:pt>
                <c:pt idx="7">
                  <c:v>5.8677878312443168</c:v>
                </c:pt>
                <c:pt idx="8">
                  <c:v>-4.7144127211810556</c:v>
                </c:pt>
                <c:pt idx="9">
                  <c:v>4.1865769703455511</c:v>
                </c:pt>
                <c:pt idx="10">
                  <c:v>-4.2424391321726018</c:v>
                </c:pt>
                <c:pt idx="11">
                  <c:v>-3.2499554552703036</c:v>
                </c:pt>
                <c:pt idx="12">
                  <c:v>4.2559627574288541</c:v>
                </c:pt>
                <c:pt idx="13">
                  <c:v>1.2249483879814154</c:v>
                </c:pt>
                <c:pt idx="14">
                  <c:v>-2.9595179599238066</c:v>
                </c:pt>
                <c:pt idx="15">
                  <c:v>-2.758573245132768</c:v>
                </c:pt>
                <c:pt idx="16">
                  <c:v>3.8292320276484695</c:v>
                </c:pt>
                <c:pt idx="17">
                  <c:v>2.2717904186377251</c:v>
                </c:pt>
                <c:pt idx="18">
                  <c:v>-4.3160148541435124</c:v>
                </c:pt>
                <c:pt idx="19">
                  <c:v>3.5368738085236338</c:v>
                </c:pt>
                <c:pt idx="20">
                  <c:v>3.3362832491212111</c:v>
                </c:pt>
                <c:pt idx="21">
                  <c:v>6.6472508116560647</c:v>
                </c:pt>
                <c:pt idx="22">
                  <c:v>3.2872495733694387</c:v>
                </c:pt>
                <c:pt idx="23">
                  <c:v>-2.8169764886037054</c:v>
                </c:pt>
                <c:pt idx="24">
                  <c:v>5.9791996413983624</c:v>
                </c:pt>
                <c:pt idx="25">
                  <c:v>5.1873993460312828</c:v>
                </c:pt>
                <c:pt idx="26">
                  <c:v>1.8264372057409493</c:v>
                </c:pt>
                <c:pt idx="27">
                  <c:v>-3.7247514949269722</c:v>
                </c:pt>
                <c:pt idx="28">
                  <c:v>5.1086015268699079</c:v>
                </c:pt>
                <c:pt idx="29">
                  <c:v>-4.54</c:v>
                </c:pt>
                <c:pt idx="30">
                  <c:v>1.9423436152365021</c:v>
                </c:pt>
                <c:pt idx="31">
                  <c:v>8.6935119982924878</c:v>
                </c:pt>
                <c:pt idx="32">
                  <c:v>-4.7975032571989953</c:v>
                </c:pt>
                <c:pt idx="33">
                  <c:v>-4.3458597139083075</c:v>
                </c:pt>
                <c:pt idx="34">
                  <c:v>4.359184547539769</c:v>
                </c:pt>
                <c:pt idx="35">
                  <c:v>-6.0039052409920988</c:v>
                </c:pt>
                <c:pt idx="36">
                  <c:v>3.1692468810032377</c:v>
                </c:pt>
                <c:pt idx="37">
                  <c:v>4.646530196530847</c:v>
                </c:pt>
                <c:pt idx="38">
                  <c:v>3.7293398780633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C50D-4198-961C-87496430D1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4825600"/>
        <c:axId val="85090304"/>
      </c:scatterChart>
      <c:valAx>
        <c:axId val="84825600"/>
        <c:scaling>
          <c:orientation val="minMax"/>
        </c:scaling>
        <c:delete val="0"/>
        <c:axPos val="b"/>
        <c:numFmt formatCode="0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ES"/>
          </a:p>
        </c:txPr>
        <c:crossAx val="85090304"/>
        <c:crosses val="autoZero"/>
        <c:crossBetween val="midCat"/>
      </c:valAx>
      <c:valAx>
        <c:axId val="85090304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ES"/>
          </a:p>
        </c:txPr>
        <c:crossAx val="8482560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1">
    <c:autoUpdate val="0"/>
  </c:externalData>
  <c:userShapes r:id="rId2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59868</cdr:x>
      <cdr:y>0.03143</cdr:y>
    </cdr:from>
    <cdr:to>
      <cdr:x>0.77193</cdr:x>
      <cdr:y>0.105</cdr:y>
    </cdr:to>
    <cdr:sp macro="" textlink="">
      <cdr:nvSpPr>
        <cdr:cNvPr id="2" name="CuadroTexto 1"/>
        <cdr:cNvSpPr txBox="1"/>
      </cdr:nvSpPr>
      <cdr:spPr>
        <a:xfrm xmlns:a="http://schemas.openxmlformats.org/drawingml/2006/main">
          <a:off x="2737169" y="86219"/>
          <a:ext cx="792088" cy="20181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s-ES" sz="11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R = 0.87</a:t>
          </a:r>
          <a:endParaRPr lang="es-ES" sz="11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71800" cy="496888"/>
          </a:xfrm>
          <a:prstGeom prst="rect">
            <a:avLst/>
          </a:prstGeom>
        </p:spPr>
        <p:txBody>
          <a:bodyPr vert="horz" lIns="91392" tIns="45698" rIns="91392" bIns="45698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7" y="0"/>
            <a:ext cx="2971800" cy="496888"/>
          </a:xfrm>
          <a:prstGeom prst="rect">
            <a:avLst/>
          </a:prstGeom>
        </p:spPr>
        <p:txBody>
          <a:bodyPr vert="horz" lIns="91392" tIns="45698" rIns="91392" bIns="45698" rtlCol="0"/>
          <a:lstStyle>
            <a:lvl1pPr algn="r">
              <a:defRPr sz="1200"/>
            </a:lvl1pPr>
          </a:lstStyle>
          <a:p>
            <a:fld id="{72B78F72-AAAC-42DC-B26A-88E113706900}" type="datetimeFigureOut">
              <a:rPr lang="es-ES" smtClean="0"/>
              <a:t>04/07/2018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109788" y="746125"/>
            <a:ext cx="2638425" cy="3730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392" tIns="45698" rIns="91392" bIns="45698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1" y="4724401"/>
            <a:ext cx="5486400" cy="4476750"/>
          </a:xfrm>
          <a:prstGeom prst="rect">
            <a:avLst/>
          </a:prstGeom>
        </p:spPr>
        <p:txBody>
          <a:bodyPr vert="horz" lIns="91392" tIns="45698" rIns="91392" bIns="45698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1" y="9448801"/>
            <a:ext cx="2971800" cy="496888"/>
          </a:xfrm>
          <a:prstGeom prst="rect">
            <a:avLst/>
          </a:prstGeom>
        </p:spPr>
        <p:txBody>
          <a:bodyPr vert="horz" lIns="91392" tIns="45698" rIns="91392" bIns="45698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7" y="9448801"/>
            <a:ext cx="2971800" cy="496888"/>
          </a:xfrm>
          <a:prstGeom prst="rect">
            <a:avLst/>
          </a:prstGeom>
        </p:spPr>
        <p:txBody>
          <a:bodyPr vert="horz" lIns="91392" tIns="45698" rIns="91392" bIns="45698" rtlCol="0" anchor="b"/>
          <a:lstStyle>
            <a:lvl1pPr algn="r">
              <a:defRPr sz="1200"/>
            </a:lvl1pPr>
          </a:lstStyle>
          <a:p>
            <a:fld id="{42FA20B8-F23D-46C9-91F7-0683655A117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600721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1pPr>
    <a:lvl2pPr marL="521437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2pPr>
    <a:lvl3pPr marL="104287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3pPr>
    <a:lvl4pPr marL="156431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4pPr>
    <a:lvl5pPr marL="2085746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5pPr>
    <a:lvl6pPr marL="260718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6pPr>
    <a:lvl7pPr marL="312862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7pPr>
    <a:lvl8pPr marL="3650056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8pPr>
    <a:lvl9pPr marL="417149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66976" y="3321395"/>
            <a:ext cx="6425724" cy="2291810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133951" y="6058694"/>
            <a:ext cx="5291773" cy="2732352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8BCF9-E7DC-43B9-A9CA-D269F2D89CCB}" type="datetimeFigureOut">
              <a:rPr lang="es-ES" smtClean="0"/>
              <a:t>04/07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7F60D-D6D3-4846-9309-815741290AF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154648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8BCF9-E7DC-43B9-A9CA-D269F2D89CCB}" type="datetimeFigureOut">
              <a:rPr lang="es-ES" smtClean="0"/>
              <a:t>04/07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7F60D-D6D3-4846-9309-815741290AF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420403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110573" y="571716"/>
            <a:ext cx="1275696" cy="12161937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83489" y="571716"/>
            <a:ext cx="3701091" cy="12161937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8BCF9-E7DC-43B9-A9CA-D269F2D89CCB}" type="datetimeFigureOut">
              <a:rPr lang="es-ES" smtClean="0"/>
              <a:t>04/07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7F60D-D6D3-4846-9309-815741290AF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8039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8BCF9-E7DC-43B9-A9CA-D269F2D89CCB}" type="datetimeFigureOut">
              <a:rPr lang="es-ES" smtClean="0"/>
              <a:t>04/07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7F60D-D6D3-4846-9309-815741290AF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021099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97162" y="6870480"/>
            <a:ext cx="6425724" cy="21235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97162" y="4531650"/>
            <a:ext cx="6425724" cy="2338833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8BCF9-E7DC-43B9-A9CA-D269F2D89CCB}" type="datetimeFigureOut">
              <a:rPr lang="es-ES" smtClean="0"/>
              <a:t>04/07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7F60D-D6D3-4846-9309-815741290AF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826751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83489" y="3326343"/>
            <a:ext cx="2488393" cy="940731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897877" y="3326343"/>
            <a:ext cx="2488393" cy="940731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8BCF9-E7DC-43B9-A9CA-D269F2D89CCB}" type="datetimeFigureOut">
              <a:rPr lang="es-ES" smtClean="0"/>
              <a:t>04/07/2018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7F60D-D6D3-4846-9309-815741290AF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60559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77984" y="428168"/>
            <a:ext cx="6803708" cy="1781969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77986" y="2393283"/>
            <a:ext cx="3340169" cy="99740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77986" y="3390690"/>
            <a:ext cx="3340169" cy="616016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840212" y="2393283"/>
            <a:ext cx="3341481" cy="99740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840212" y="3390690"/>
            <a:ext cx="3341481" cy="616016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8BCF9-E7DC-43B9-A9CA-D269F2D89CCB}" type="datetimeFigureOut">
              <a:rPr lang="es-ES" smtClean="0"/>
              <a:t>04/07/2018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7F60D-D6D3-4846-9309-815741290AF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063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8BCF9-E7DC-43B9-A9CA-D269F2D89CCB}" type="datetimeFigureOut">
              <a:rPr lang="es-ES" smtClean="0"/>
              <a:t>04/07/2018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7F60D-D6D3-4846-9309-815741290AF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123440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8BCF9-E7DC-43B9-A9CA-D269F2D89CCB}" type="datetimeFigureOut">
              <a:rPr lang="es-ES" smtClean="0"/>
              <a:t>04/07/2018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7F60D-D6D3-4846-9309-815741290AF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41292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77986" y="425693"/>
            <a:ext cx="2487081" cy="181166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955624" y="425696"/>
            <a:ext cx="4226069" cy="912516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77986" y="2237363"/>
            <a:ext cx="2487081" cy="731349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8BCF9-E7DC-43B9-A9CA-D269F2D89CCB}" type="datetimeFigureOut">
              <a:rPr lang="es-ES" smtClean="0"/>
              <a:t>04/07/2018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7F60D-D6D3-4846-9309-815741290AF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230919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481749" y="7484271"/>
            <a:ext cx="4535805" cy="88356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481749" y="955333"/>
            <a:ext cx="4535805" cy="6415088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481749" y="8367832"/>
            <a:ext cx="4535805" cy="125480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8BCF9-E7DC-43B9-A9CA-D269F2D89CCB}" type="datetimeFigureOut">
              <a:rPr lang="es-ES" smtClean="0"/>
              <a:t>04/07/2018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7F60D-D6D3-4846-9309-815741290AF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84026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77984" y="428168"/>
            <a:ext cx="6803708" cy="17819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77984" y="2494759"/>
            <a:ext cx="6803708" cy="70561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77984" y="9909730"/>
            <a:ext cx="1763924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78BCF9-E7DC-43B9-A9CA-D269F2D89CCB}" type="datetimeFigureOut">
              <a:rPr lang="es-ES" smtClean="0"/>
              <a:t>04/07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582889" y="9909730"/>
            <a:ext cx="239389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5417767" y="9909730"/>
            <a:ext cx="1763924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F7F60D-D6D3-4846-9309-815741290AF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650787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ángulo 1"/>
          <p:cNvSpPr/>
          <p:nvPr/>
        </p:nvSpPr>
        <p:spPr>
          <a:xfrm>
            <a:off x="425018" y="341917"/>
            <a:ext cx="6122544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upplementary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Tabla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67629066"/>
              </p:ext>
            </p:extLst>
          </p:nvPr>
        </p:nvGraphicFramePr>
        <p:xfrm>
          <a:off x="971525" y="1385466"/>
          <a:ext cx="5688632" cy="2359090"/>
        </p:xfrm>
        <a:graphic>
          <a:graphicData uri="http://schemas.openxmlformats.org/drawingml/2006/table">
            <a:tbl>
              <a:tblPr/>
              <a:tblGrid>
                <a:gridCol w="1159049">
                  <a:extLst>
                    <a:ext uri="{9D8B030D-6E8A-4147-A177-3AD203B41FA5}">
                      <a16:colId xmlns:a16="http://schemas.microsoft.com/office/drawing/2014/main" xmlns="" val="941303089"/>
                    </a:ext>
                  </a:extLst>
                </a:gridCol>
                <a:gridCol w="1467947">
                  <a:extLst>
                    <a:ext uri="{9D8B030D-6E8A-4147-A177-3AD203B41FA5}">
                      <a16:colId xmlns:a16="http://schemas.microsoft.com/office/drawing/2014/main" xmlns="" val="3037386452"/>
                    </a:ext>
                  </a:extLst>
                </a:gridCol>
                <a:gridCol w="590458">
                  <a:extLst>
                    <a:ext uri="{9D8B030D-6E8A-4147-A177-3AD203B41FA5}">
                      <a16:colId xmlns:a16="http://schemas.microsoft.com/office/drawing/2014/main" xmlns="" val="786330386"/>
                    </a:ext>
                  </a:extLst>
                </a:gridCol>
                <a:gridCol w="1126245">
                  <a:extLst>
                    <a:ext uri="{9D8B030D-6E8A-4147-A177-3AD203B41FA5}">
                      <a16:colId xmlns:a16="http://schemas.microsoft.com/office/drawing/2014/main" xmlns="" val="1895301685"/>
                    </a:ext>
                  </a:extLst>
                </a:gridCol>
                <a:gridCol w="1344933">
                  <a:extLst>
                    <a:ext uri="{9D8B030D-6E8A-4147-A177-3AD203B41FA5}">
                      <a16:colId xmlns:a16="http://schemas.microsoft.com/office/drawing/2014/main" xmlns="" val="3134129410"/>
                    </a:ext>
                  </a:extLst>
                </a:gridCol>
              </a:tblGrid>
              <a:tr h="151338">
                <a:tc>
                  <a:txBody>
                    <a:bodyPr/>
                    <a:lstStyle/>
                    <a:p>
                      <a:pPr algn="ctr" fontAlgn="ctr"/>
                      <a:r>
                        <a:rPr lang="es-ES" sz="900" b="1" i="0" u="none" strike="noStrike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anscript</a:t>
                      </a:r>
                      <a:r>
                        <a:rPr lang="es-ES" sz="900" b="1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D</a:t>
                      </a:r>
                      <a:endParaRPr lang="es-ES" sz="900" b="1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2" marR="8902" marT="890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900" b="1" i="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notation</a:t>
                      </a:r>
                      <a:endParaRPr lang="es-ES" sz="900" b="1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2" marR="8902" marT="890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900" b="1" i="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ssue</a:t>
                      </a:r>
                      <a:endParaRPr lang="es-ES" sz="900" b="1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2" marR="8902" marT="890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900" b="1" i="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otype</a:t>
                      </a:r>
                      <a:r>
                        <a:rPr lang="es-ES" sz="900" b="1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s-ES" sz="900" b="1" i="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atment</a:t>
                      </a:r>
                      <a:endParaRPr lang="es-ES" sz="900" b="1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2" marR="8902" marT="890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900" b="1" i="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lative</a:t>
                      </a:r>
                      <a:r>
                        <a:rPr lang="es-ES" sz="900" b="1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900" b="1" i="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</a:t>
                      </a:r>
                      <a:r>
                        <a:rPr lang="es-ES" sz="900" b="1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2</a:t>
                      </a:r>
                      <a:r>
                        <a:rPr lang="es-ES" sz="900" b="1" i="0" u="none" strike="noStrike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∆∆</a:t>
                      </a:r>
                      <a:r>
                        <a:rPr lang="es-ES" sz="900" b="1" i="0" u="none" strike="noStrike" baseline="300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</a:t>
                      </a:r>
                      <a:r>
                        <a:rPr lang="es-ES" sz="900" b="1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8902" marR="8902" marT="890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63157748"/>
                  </a:ext>
                </a:extLst>
              </a:tr>
              <a:tr h="16024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s-E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lyc06g066830.2.1</a:t>
                      </a:r>
                    </a:p>
                  </a:txBody>
                  <a:tcPr marL="8902" marR="8902" marT="890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s-ES" sz="9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20OX-2</a:t>
                      </a:r>
                      <a:endParaRPr lang="es-ES" sz="9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2" marR="8902" marT="890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s-E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ot</a:t>
                      </a:r>
                    </a:p>
                  </a:txBody>
                  <a:tcPr marL="8902" marR="8902" marT="890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s-ES" sz="900" b="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 </a:t>
                      </a:r>
                      <a:r>
                        <a:rPr lang="es-E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control)</a:t>
                      </a:r>
                    </a:p>
                  </a:txBody>
                  <a:tcPr marL="8902" marR="8902" marT="8902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s-E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 ± </a:t>
                      </a:r>
                      <a:r>
                        <a:rPr lang="es-ES" sz="9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  <a:endParaRPr lang="es-ES" sz="9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2" marR="8902" marT="8902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726441808"/>
                  </a:ext>
                </a:extLst>
              </a:tr>
              <a:tr h="160240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s-E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 (control)</a:t>
                      </a:r>
                    </a:p>
                  </a:txBody>
                  <a:tcPr marL="8902" marR="8902" marT="8902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s-E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 ± </a:t>
                      </a:r>
                      <a:r>
                        <a:rPr lang="es-ES" sz="9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  <a:endParaRPr lang="es-ES" sz="9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2" marR="8902" marT="8902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607851197"/>
                  </a:ext>
                </a:extLst>
              </a:tr>
              <a:tr h="16024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s-E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lyc12g089380.1.1</a:t>
                      </a:r>
                    </a:p>
                  </a:txBody>
                  <a:tcPr marL="8902" marR="8902" marT="890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s-ES" sz="900" b="0" i="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ansin</a:t>
                      </a:r>
                      <a:endParaRPr lang="es-ES" sz="9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2" marR="8902" marT="890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s-E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ot</a:t>
                      </a:r>
                    </a:p>
                  </a:txBody>
                  <a:tcPr marL="8902" marR="8902" marT="890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s-ES" sz="900" b="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 </a:t>
                      </a:r>
                      <a:r>
                        <a:rPr lang="es-ES" sz="9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control)</a:t>
                      </a:r>
                      <a:endParaRPr lang="es-ES" sz="9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2" marR="8902" marT="8902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s-E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  ± </a:t>
                      </a:r>
                      <a:r>
                        <a:rPr lang="es-ES" sz="9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  <a:endParaRPr lang="es-ES" sz="9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2" marR="8902" marT="8902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152498186"/>
                  </a:ext>
                </a:extLst>
              </a:tr>
              <a:tr h="160240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s-E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 (control)</a:t>
                      </a:r>
                    </a:p>
                  </a:txBody>
                  <a:tcPr marL="8902" marR="8902" marT="8902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s-E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 ± </a:t>
                      </a:r>
                      <a:r>
                        <a:rPr lang="es-ES" sz="9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  <a:endParaRPr lang="es-ES" sz="9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2" marR="8902" marT="8902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219893010"/>
                  </a:ext>
                </a:extLst>
              </a:tr>
              <a:tr h="16024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s-E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lyc02g030220.1.1</a:t>
                      </a:r>
                    </a:p>
                  </a:txBody>
                  <a:tcPr marL="8902" marR="8902" marT="890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s-ES" sz="900" b="0" i="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tensin</a:t>
                      </a:r>
                      <a:endParaRPr lang="es-ES" sz="9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2" marR="8902" marT="890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s-E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ot</a:t>
                      </a:r>
                    </a:p>
                  </a:txBody>
                  <a:tcPr marL="8902" marR="8902" marT="890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s-ES" sz="900" b="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 </a:t>
                      </a:r>
                      <a:r>
                        <a:rPr lang="es-ES" sz="9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control)</a:t>
                      </a:r>
                      <a:endParaRPr lang="es-ES" sz="9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2" marR="8902" marT="8902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s-E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  ± </a:t>
                      </a:r>
                      <a:r>
                        <a:rPr lang="es-ES" sz="9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  <a:endParaRPr lang="es-ES" sz="9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2" marR="8902" marT="8902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538436027"/>
                  </a:ext>
                </a:extLst>
              </a:tr>
              <a:tr h="160240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s-E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 (control)</a:t>
                      </a:r>
                    </a:p>
                  </a:txBody>
                  <a:tcPr marL="8902" marR="8902" marT="8902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s-E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 ± </a:t>
                      </a:r>
                      <a:r>
                        <a:rPr lang="es-ES" sz="9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  <a:endParaRPr lang="es-ES" sz="9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2" marR="8902" marT="8902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46216359"/>
                  </a:ext>
                </a:extLst>
              </a:tr>
              <a:tr h="160240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s-E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lyc09g082280.2.1</a:t>
                      </a:r>
                    </a:p>
                  </a:txBody>
                  <a:tcPr marL="8902" marR="8902" marT="890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s-ES" sz="900" b="0" i="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</a:t>
                      </a:r>
                      <a:r>
                        <a:rPr lang="es-E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LTP</a:t>
                      </a:r>
                    </a:p>
                  </a:txBody>
                  <a:tcPr marL="8902" marR="8902" marT="890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s-ES" sz="900" b="0" i="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ot</a:t>
                      </a:r>
                      <a:endParaRPr lang="es-ES" sz="9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2" marR="8902" marT="890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s-ES" sz="900" b="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 </a:t>
                      </a:r>
                      <a:r>
                        <a:rPr lang="es-ES" sz="9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control)</a:t>
                      </a:r>
                      <a:endParaRPr lang="es-ES" sz="9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2" marR="8902" marT="8902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4.01 ± </a:t>
                      </a:r>
                      <a:r>
                        <a:rPr lang="es-ES" sz="9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3.68</a:t>
                      </a:r>
                      <a:endParaRPr lang="es-ES" sz="9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2" marR="8902" marT="89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110094134"/>
                  </a:ext>
                </a:extLst>
              </a:tr>
              <a:tr h="151338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s-E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 (control)</a:t>
                      </a:r>
                    </a:p>
                  </a:txBody>
                  <a:tcPr marL="8902" marR="8902" marT="8902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 ± </a:t>
                      </a:r>
                      <a:r>
                        <a:rPr lang="es-ES" sz="9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  <a:endParaRPr lang="es-ES" sz="9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2" marR="8902" marT="89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421121864"/>
                  </a:ext>
                </a:extLst>
              </a:tr>
              <a:tr h="151338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s-ES" sz="900" b="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</a:t>
                      </a:r>
                      <a:r>
                        <a:rPr lang="es-E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lang="es-ES" sz="900" b="0" i="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lt</a:t>
                      </a:r>
                      <a:r>
                        <a:rPr lang="es-E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8902" marR="8902" marT="8902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6.88 ± </a:t>
                      </a:r>
                      <a:r>
                        <a:rPr lang="es-ES" sz="9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1.74</a:t>
                      </a:r>
                      <a:endParaRPr lang="es-ES" sz="9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2" marR="8902" marT="89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143921807"/>
                  </a:ext>
                </a:extLst>
              </a:tr>
              <a:tr h="160240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s-E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 (</a:t>
                      </a:r>
                      <a:r>
                        <a:rPr lang="es-ES" sz="900" b="0" i="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lt</a:t>
                      </a:r>
                      <a:r>
                        <a:rPr lang="es-E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8902" marR="8902" marT="8902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764.53 ± </a:t>
                      </a:r>
                      <a:r>
                        <a:rPr lang="es-ES" sz="9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4.24</a:t>
                      </a:r>
                      <a:endParaRPr lang="es-ES" sz="9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2" marR="8902" marT="89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067786779"/>
                  </a:ext>
                </a:extLst>
              </a:tr>
              <a:tr h="160240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lyc05g041770.1.1</a:t>
                      </a:r>
                    </a:p>
                  </a:txBody>
                  <a:tcPr marL="8902" marR="8902" marT="890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s-E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uanylate-binding protein 1</a:t>
                      </a:r>
                    </a:p>
                  </a:txBody>
                  <a:tcPr marL="8902" marR="8902" marT="890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s-E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af</a:t>
                      </a:r>
                    </a:p>
                  </a:txBody>
                  <a:tcPr marL="8902" marR="8902" marT="890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s-ES" sz="900" b="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 </a:t>
                      </a:r>
                      <a:r>
                        <a:rPr lang="es-ES" sz="9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control)</a:t>
                      </a:r>
                      <a:endParaRPr lang="es-ES" sz="9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2" marR="8902" marT="8902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05 ± </a:t>
                      </a:r>
                      <a:r>
                        <a:rPr lang="es-ES" sz="9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9</a:t>
                      </a:r>
                      <a:endParaRPr lang="es-ES" sz="9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2" marR="8902" marT="89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570741868"/>
                  </a:ext>
                </a:extLst>
              </a:tr>
              <a:tr h="151338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s-E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 (control)</a:t>
                      </a:r>
                    </a:p>
                  </a:txBody>
                  <a:tcPr marL="8902" marR="8902" marT="8902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 ± </a:t>
                      </a:r>
                      <a:r>
                        <a:rPr lang="es-ES" sz="9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  <a:endParaRPr lang="es-ES" sz="9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2" marR="8902" marT="89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414179146"/>
                  </a:ext>
                </a:extLst>
              </a:tr>
              <a:tr h="151338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s-ES" sz="900" b="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</a:t>
                      </a:r>
                      <a:r>
                        <a:rPr lang="es-E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lang="es-ES" sz="900" b="0" i="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lt</a:t>
                      </a:r>
                      <a:r>
                        <a:rPr lang="es-E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8902" marR="8902" marT="8902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67 ± </a:t>
                      </a:r>
                      <a:r>
                        <a:rPr lang="es-ES" sz="9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8</a:t>
                      </a:r>
                      <a:endParaRPr lang="es-ES" sz="9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2" marR="8902" marT="89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515467247"/>
                  </a:ext>
                </a:extLst>
              </a:tr>
              <a:tr h="160240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s-E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 (</a:t>
                      </a:r>
                      <a:r>
                        <a:rPr lang="es-ES" sz="900" b="0" i="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lt</a:t>
                      </a:r>
                      <a:r>
                        <a:rPr lang="es-E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8902" marR="8902" marT="8902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3 ± </a:t>
                      </a:r>
                      <a:r>
                        <a:rPr lang="es-ES" sz="9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</a:t>
                      </a:r>
                      <a:endParaRPr lang="es-ES" sz="9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2" marR="8902" marT="89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807850285"/>
                  </a:ext>
                </a:extLst>
              </a:tr>
            </a:tbl>
          </a:graphicData>
        </a:graphic>
      </p:graphicFrame>
      <p:sp>
        <p:nvSpPr>
          <p:cNvPr id="6" name="8 CuadroTexto"/>
          <p:cNvSpPr txBox="1"/>
          <p:nvPr/>
        </p:nvSpPr>
        <p:spPr>
          <a:xfrm>
            <a:off x="681629" y="1025426"/>
            <a:ext cx="3931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7" name="8 CuadroTexto"/>
          <p:cNvSpPr txBox="1"/>
          <p:nvPr/>
        </p:nvSpPr>
        <p:spPr>
          <a:xfrm>
            <a:off x="681629" y="4326744"/>
            <a:ext cx="3931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grpSp>
        <p:nvGrpSpPr>
          <p:cNvPr id="8" name="Grupo 7"/>
          <p:cNvGrpSpPr/>
          <p:nvPr/>
        </p:nvGrpSpPr>
        <p:grpSpPr>
          <a:xfrm>
            <a:off x="1474717" y="4405056"/>
            <a:ext cx="4576301" cy="2747947"/>
            <a:chOff x="1123879" y="3631149"/>
            <a:chExt cx="4576301" cy="2747947"/>
          </a:xfrm>
        </p:grpSpPr>
        <p:graphicFrame>
          <p:nvGraphicFramePr>
            <p:cNvPr id="9" name="Gráfico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37151964"/>
                </p:ext>
              </p:extLst>
            </p:nvPr>
          </p:nvGraphicFramePr>
          <p:xfrm>
            <a:off x="1123879" y="3635896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CuadroTexto 4"/>
            <p:cNvSpPr txBox="1"/>
            <p:nvPr/>
          </p:nvSpPr>
          <p:spPr>
            <a:xfrm rot="16200000">
              <a:off x="2631396" y="3996705"/>
              <a:ext cx="10081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qRT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PCR</a:t>
              </a:r>
            </a:p>
          </p:txBody>
        </p:sp>
        <p:sp>
          <p:nvSpPr>
            <p:cNvPr id="10" name="CuadroTexto 9"/>
            <p:cNvSpPr txBox="1"/>
            <p:nvPr/>
          </p:nvSpPr>
          <p:spPr>
            <a:xfrm>
              <a:off x="4692068" y="4674717"/>
              <a:ext cx="10081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croarray</a:t>
              </a:r>
              <a:endParaRPr lang="es-E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851937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41</TotalTime>
  <Words>137</Words>
  <Application>Microsoft Office PowerPoint</Application>
  <PresentationFormat>Personalizado</PresentationFormat>
  <Paragraphs>54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aloma Sánchez Bel</dc:creator>
  <cp:lastModifiedBy>Irene</cp:lastModifiedBy>
  <cp:revision>497</cp:revision>
  <cp:lastPrinted>2017-10-24T16:42:37Z</cp:lastPrinted>
  <dcterms:created xsi:type="dcterms:W3CDTF">2016-11-10T12:20:59Z</dcterms:created>
  <dcterms:modified xsi:type="dcterms:W3CDTF">2018-07-04T18:00:34Z</dcterms:modified>
</cp:coreProperties>
</file>